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60" r:id="rId1"/>
    <p:sldMasterId id="2147483672" r:id="rId2"/>
  </p:sldMasterIdLst>
  <p:notesMasterIdLst>
    <p:notesMasterId r:id="rId6"/>
  </p:notesMasterIdLst>
  <p:sldIdLst>
    <p:sldId id="270" r:id="rId3"/>
    <p:sldId id="271" r:id="rId4"/>
    <p:sldId id="272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501" autoAdjust="0"/>
    <p:restoredTop sz="85200" autoAdjust="0"/>
  </p:normalViewPr>
  <p:slideViewPr>
    <p:cSldViewPr snapToGrid="0">
      <p:cViewPr varScale="1">
        <p:scale>
          <a:sx n="117" d="100"/>
          <a:sy n="117" d="100"/>
        </p:scale>
        <p:origin x="1014" y="108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cat>
            <c:numRef>
              <c:f>Sheet1!$D$17:$J$17</c:f>
              <c:numCache>
                <c:formatCode>General</c:formatCode>
                <c:ptCount val="7"/>
                <c:pt idx="0">
                  <c:v>-3</c:v>
                </c:pt>
                <c:pt idx="1">
                  <c:v>-2</c:v>
                </c:pt>
                <c:pt idx="2">
                  <c:v>-1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3</c:v>
                </c:pt>
              </c:numCache>
            </c:numRef>
          </c:cat>
          <c:val>
            <c:numRef>
              <c:f>Sheet1!$D$18:$J$18</c:f>
              <c:numCache>
                <c:formatCode>General</c:formatCode>
                <c:ptCount val="7"/>
                <c:pt idx="0">
                  <c:v>0</c:v>
                </c:pt>
                <c:pt idx="1">
                  <c:v>0.4</c:v>
                </c:pt>
                <c:pt idx="2">
                  <c:v>1.4</c:v>
                </c:pt>
                <c:pt idx="3">
                  <c:v>89.7</c:v>
                </c:pt>
                <c:pt idx="4">
                  <c:v>3.4</c:v>
                </c:pt>
                <c:pt idx="5">
                  <c:v>3.6</c:v>
                </c:pt>
                <c:pt idx="6">
                  <c:v>1.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89104608"/>
        <c:axId val="252321376"/>
      </c:barChart>
      <c:catAx>
        <c:axId val="1891046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52321376"/>
        <c:crosses val="autoZero"/>
        <c:auto val="1"/>
        <c:lblAlgn val="ctr"/>
        <c:lblOffset val="100"/>
        <c:noMultiLvlLbl val="0"/>
      </c:catAx>
      <c:valAx>
        <c:axId val="2523213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91046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cat>
            <c:numRef>
              <c:f>Sheet1!$B$22:$L$22</c:f>
              <c:numCache>
                <c:formatCode>General</c:formatCode>
                <c:ptCount val="11"/>
                <c:pt idx="0">
                  <c:v>-5</c:v>
                </c:pt>
                <c:pt idx="1">
                  <c:v>-4</c:v>
                </c:pt>
                <c:pt idx="2">
                  <c:v>-3</c:v>
                </c:pt>
                <c:pt idx="3">
                  <c:v>-2</c:v>
                </c:pt>
                <c:pt idx="4">
                  <c:v>-1</c:v>
                </c:pt>
                <c:pt idx="5">
                  <c:v>0</c:v>
                </c:pt>
                <c:pt idx="6">
                  <c:v>1</c:v>
                </c:pt>
                <c:pt idx="7">
                  <c:v>2</c:v>
                </c:pt>
                <c:pt idx="8">
                  <c:v>3</c:v>
                </c:pt>
                <c:pt idx="9">
                  <c:v>4</c:v>
                </c:pt>
                <c:pt idx="10">
                  <c:v>5</c:v>
                </c:pt>
              </c:numCache>
            </c:numRef>
          </c:cat>
          <c:val>
            <c:numRef>
              <c:f>Sheet1!$B$23:$L$2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.6</c:v>
                </c:pt>
                <c:pt idx="3">
                  <c:v>0.6</c:v>
                </c:pt>
                <c:pt idx="4">
                  <c:v>0.6</c:v>
                </c:pt>
                <c:pt idx="5">
                  <c:v>48.6</c:v>
                </c:pt>
                <c:pt idx="6">
                  <c:v>22.4</c:v>
                </c:pt>
                <c:pt idx="7">
                  <c:v>17.100000000000001</c:v>
                </c:pt>
                <c:pt idx="8">
                  <c:v>9.1</c:v>
                </c:pt>
                <c:pt idx="9">
                  <c:v>0.4</c:v>
                </c:pt>
                <c:pt idx="10">
                  <c:v>0.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58772496"/>
        <c:axId val="258773056"/>
      </c:barChart>
      <c:catAx>
        <c:axId val="258772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58773056"/>
        <c:crosses val="autoZero"/>
        <c:auto val="1"/>
        <c:lblAlgn val="ctr"/>
        <c:lblOffset val="100"/>
        <c:noMultiLvlLbl val="0"/>
      </c:catAx>
      <c:valAx>
        <c:axId val="2587730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58772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2F03C0-FEEE-4CD2-9C11-2EED6FB6B117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032874-FA18-4720-A73E-9F6BA08E74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67968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D84E8A-6423-427E-8761-1CEDBC117F40}" type="slidenum">
              <a:rPr lang="ja-JP" altLang="en-US" smtClean="0">
                <a:solidFill>
                  <a:prstClr val="black"/>
                </a:solidFill>
              </a:rPr>
              <a:pPr/>
              <a:t>1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6264419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D84E8A-6423-427E-8761-1CEDBC117F40}" type="slidenum">
              <a:rPr lang="ja-JP" altLang="en-US" smtClean="0">
                <a:solidFill>
                  <a:prstClr val="black"/>
                </a:solidFill>
              </a:rPr>
              <a:pPr/>
              <a:t>2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0302023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 smtClean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D84E8A-6423-427E-8761-1CEDBC117F40}" type="slidenum">
              <a:rPr lang="ja-JP" altLang="en-US" smtClean="0">
                <a:solidFill>
                  <a:prstClr val="black"/>
                </a:solidFill>
              </a:rPr>
              <a:pPr/>
              <a:t>3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38524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6E8C1-2441-4A2B-AA50-2ABB8FF2D114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65204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66B8B-FE98-4261-9174-769BA8A07414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638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D5762-0C9A-41E0-BE16-C9BC19BFB375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9352352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6E8C1-2441-4A2B-AA50-2ABB8FF2D114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7932258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3E7C1-FDA1-41AC-BC39-F61309A93802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5228347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ED0C4-1862-4BE7-B4F1-E7A1AA8F20D0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2874458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C38D4-BA5E-46C6-8722-637E80B0C1DE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1146554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15728-88C4-42C9-AECE-40579E75FDA1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994147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E1D48-B264-4C74-AF84-7B6406D0A0F6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1478295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1E21FF-1F56-4862-B88D-992055F6EE4F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6870575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46910-C5AC-44D9-8437-7BA6B206B09A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71906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3E7C1-FDA1-41AC-BC39-F61309A93802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1747247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E3006-88FF-4354-93C2-A8CBF0C1CA45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4237174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66B8B-FE98-4261-9174-769BA8A07414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1027138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D5762-0C9A-41E0-BE16-C9BC19BFB375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91526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ED0C4-1862-4BE7-B4F1-E7A1AA8F20D0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29460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C38D4-BA5E-46C6-8722-637E80B0C1DE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35455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15728-88C4-42C9-AECE-40579E75FDA1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66377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E1D48-B264-4C74-AF84-7B6406D0A0F6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746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1E21FF-1F56-4862-B88D-992055F6EE4F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29660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46910-C5AC-44D9-8437-7BA6B206B09A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207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E3006-88FF-4354-93C2-A8CBF0C1CA45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798982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5C92E3-A362-495F-B206-38537B178F28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66271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5C92E3-A362-495F-B206-38537B178F28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9CE8EF-8FEE-440D-A14D-1474519490D8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6510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正方形/長方形 6"/>
          <p:cNvSpPr/>
          <p:nvPr/>
        </p:nvSpPr>
        <p:spPr>
          <a:xfrm>
            <a:off x="2629720" y="620930"/>
            <a:ext cx="6053063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stograms showing interval between admission and disease registry date of 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I.</a:t>
            </a:r>
            <a:endParaRPr lang="en-US" altLang="ja-JP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ja-JP" sz="1100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0760260"/>
              </p:ext>
            </p:extLst>
          </p:nvPr>
        </p:nvGraphicFramePr>
        <p:xfrm>
          <a:off x="2926496" y="1168366"/>
          <a:ext cx="5321853" cy="35666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正方形/長方形 2"/>
          <p:cNvSpPr/>
          <p:nvPr/>
        </p:nvSpPr>
        <p:spPr>
          <a:xfrm rot="16200000">
            <a:off x="1593396" y="2684463"/>
            <a:ext cx="235673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cent of patients with this difference</a:t>
            </a:r>
          </a:p>
        </p:txBody>
      </p:sp>
      <p:sp>
        <p:nvSpPr>
          <p:cNvPr id="4" name="正方形/長方形 3"/>
          <p:cNvSpPr/>
          <p:nvPr/>
        </p:nvSpPr>
        <p:spPr>
          <a:xfrm>
            <a:off x="3459505" y="5169452"/>
            <a:ext cx="4662627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fference between 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mission </a:t>
            </a:r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disease registry date of 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I</a:t>
            </a:r>
          </a:p>
          <a:p>
            <a:pPr algn="ctr"/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 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 admission </a:t>
            </a:r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te)</a:t>
            </a:r>
          </a:p>
        </p:txBody>
      </p:sp>
      <p:sp>
        <p:nvSpPr>
          <p:cNvPr id="12" name="正方形/長方形 11"/>
          <p:cNvSpPr/>
          <p:nvPr/>
        </p:nvSpPr>
        <p:spPr>
          <a:xfrm>
            <a:off x="2672926" y="4735019"/>
            <a:ext cx="786579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</a:t>
            </a:r>
            <a:endParaRPr lang="en-US" altLang="ja-JP" sz="1100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patients</a:t>
            </a:r>
            <a:endParaRPr lang="ja-JP" alt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3606221" y="4778641"/>
            <a:ext cx="436682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               2                7              452            17              18               8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2731760" y="5648199"/>
            <a:ext cx="240161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breviation: AI</a:t>
            </a:r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renal </a:t>
            </a:r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sufficiency</a:t>
            </a:r>
            <a:endParaRPr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36378910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正方形/長方形 6"/>
          <p:cNvSpPr/>
          <p:nvPr/>
        </p:nvSpPr>
        <p:spPr>
          <a:xfrm>
            <a:off x="2605666" y="632958"/>
            <a:ext cx="67669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ja-JP" sz="11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g. S2 </a:t>
            </a:r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stograms showing interval between admission and start of therapeutic GC administration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ja-JP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グラフ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0769374"/>
              </p:ext>
            </p:extLst>
          </p:nvPr>
        </p:nvGraphicFramePr>
        <p:xfrm>
          <a:off x="2999622" y="1068100"/>
          <a:ext cx="5262282" cy="35666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正方形/長方形 10"/>
          <p:cNvSpPr/>
          <p:nvPr/>
        </p:nvSpPr>
        <p:spPr>
          <a:xfrm rot="16200000">
            <a:off x="1677241" y="2589111"/>
            <a:ext cx="235673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cent of patients with this difference</a:t>
            </a:r>
          </a:p>
        </p:txBody>
      </p:sp>
      <p:sp>
        <p:nvSpPr>
          <p:cNvPr id="5" name="正方形/長方形 4"/>
          <p:cNvSpPr/>
          <p:nvPr/>
        </p:nvSpPr>
        <p:spPr>
          <a:xfrm>
            <a:off x="3009497" y="5095060"/>
            <a:ext cx="5476569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fference 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tween </a:t>
            </a:r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mission and start of therapeutic GC 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ministration</a:t>
            </a:r>
            <a:endParaRPr lang="en-US" altLang="ja-JP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 = admission </a:t>
            </a:r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te, GC 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rapy </a:t>
            </a:r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nds to 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art </a:t>
            </a:r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ter admission)</a:t>
            </a:r>
          </a:p>
        </p:txBody>
      </p:sp>
      <p:sp>
        <p:nvSpPr>
          <p:cNvPr id="14" name="正方形/長方形 13"/>
          <p:cNvSpPr/>
          <p:nvPr/>
        </p:nvSpPr>
        <p:spPr>
          <a:xfrm>
            <a:off x="2639319" y="4609324"/>
            <a:ext cx="786579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</a:t>
            </a:r>
            <a:endParaRPr lang="en-US" altLang="ja-JP" sz="1100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patients</a:t>
            </a:r>
            <a:endParaRPr lang="ja-JP" alt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正方形/長方形 14"/>
          <p:cNvSpPr/>
          <p:nvPr/>
        </p:nvSpPr>
        <p:spPr>
          <a:xfrm>
            <a:off x="3480957" y="4664249"/>
            <a:ext cx="475688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  </a:t>
            </a:r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0          3         3         3       245      113      86       46         2         3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正方形/長方形 16"/>
          <p:cNvSpPr/>
          <p:nvPr/>
        </p:nvSpPr>
        <p:spPr>
          <a:xfrm>
            <a:off x="2755386" y="5660227"/>
            <a:ext cx="207941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breviation: GC, glucocorticoid</a:t>
            </a:r>
            <a:endParaRPr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3999123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正方形/長方形 32"/>
          <p:cNvSpPr/>
          <p:nvPr/>
        </p:nvSpPr>
        <p:spPr>
          <a:xfrm>
            <a:off x="3646041" y="1039523"/>
            <a:ext cx="46493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</a:t>
            </a:r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hormone 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sting 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ring 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spitalization.</a:t>
            </a:r>
            <a:endParaRPr lang="ja-JP" alt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正方形/長方形 23"/>
          <p:cNvSpPr/>
          <p:nvPr/>
        </p:nvSpPr>
        <p:spPr>
          <a:xfrm>
            <a:off x="4094160" y="5301957"/>
            <a:ext cx="30925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breviation: ACTH, adrenocorticotropic </a:t>
            </a:r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rmone</a:t>
            </a:r>
          </a:p>
        </p:txBody>
      </p:sp>
      <p:pic>
        <p:nvPicPr>
          <p:cNvPr id="25" name="図 2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69371" y="1485971"/>
            <a:ext cx="4391526" cy="3674051"/>
          </a:xfrm>
          <a:prstGeom prst="rect">
            <a:avLst/>
          </a:prstGeom>
        </p:spPr>
      </p:pic>
      <p:sp>
        <p:nvSpPr>
          <p:cNvPr id="19" name="正方形/長方形 18"/>
          <p:cNvSpPr/>
          <p:nvPr/>
        </p:nvSpPr>
        <p:spPr>
          <a:xfrm>
            <a:off x="6880426" y="1643420"/>
            <a:ext cx="97174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ja-JP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504</a:t>
            </a:r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24703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2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8</Words>
  <Application>Microsoft Office PowerPoint</Application>
  <PresentationFormat>ワイド画面</PresentationFormat>
  <Paragraphs>22</Paragraphs>
  <Slides>3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3</vt:i4>
      </vt:variant>
    </vt:vector>
  </HeadingPairs>
  <TitlesOfParts>
    <vt:vector size="10" baseType="lpstr">
      <vt:lpstr>ＭＳ Ｐゴシック</vt:lpstr>
      <vt:lpstr>Arial</vt:lpstr>
      <vt:lpstr>Calibri</vt:lpstr>
      <vt:lpstr>Calibri Light</vt:lpstr>
      <vt:lpstr>Times New Roman</vt:lpstr>
      <vt:lpstr>1_Office テーマ</vt:lpstr>
      <vt:lpstr>2_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16-11-11T01:06:50Z</dcterms:created>
  <dcterms:modified xsi:type="dcterms:W3CDTF">2017-09-04T02:11:58Z</dcterms:modified>
</cp:coreProperties>
</file>